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6" autoAdjust="0"/>
    <p:restoredTop sz="79459" autoAdjust="0"/>
  </p:normalViewPr>
  <p:slideViewPr>
    <p:cSldViewPr snapToGrid="0">
      <p:cViewPr varScale="1">
        <p:scale>
          <a:sx n="74" d="100"/>
          <a:sy n="74" d="100"/>
        </p:scale>
        <p:origin x="384" y="6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3091FF4-D569-4FC7-9575-26680F78D8A0}" type="datetimeFigureOut">
              <a:rPr kumimoji="1" lang="ja-JP" altLang="en-US" smtClean="0"/>
              <a:pPr/>
              <a:t>2024/1/3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A1767A-17F6-43A4-B99A-055531EC9F1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73778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2A1767A-17F6-43A4-B99A-055531EC9F17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80004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8B5B8EA-79F0-4B60-898E-A573C16537B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585D51A6-242E-4F2B-B101-7E48184BE5E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47D2BEC-F954-42D3-90AE-566669FAA8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6DE90-0AAC-4704-9E25-8DA8BDEFC4C8}" type="datetimeFigureOut">
              <a:rPr kumimoji="1" lang="ja-JP" altLang="en-US" smtClean="0"/>
              <a:pPr/>
              <a:t>2024/1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DFA5828-1F13-4835-B3BF-6236706847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412BE61-1420-4780-9822-83727B760F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A05B27-057A-45C0-8760-8C28BBF415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51573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48BF5D8-995D-4340-B3AE-069C709600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E405D75-F93F-4763-9ADC-D2F01D7C61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B1A2435-0EA5-4C24-92B4-36ACC09B50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6DE90-0AAC-4704-9E25-8DA8BDEFC4C8}" type="datetimeFigureOut">
              <a:rPr kumimoji="1" lang="ja-JP" altLang="en-US" smtClean="0"/>
              <a:pPr/>
              <a:t>2024/1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A8586C4-E707-41C8-B573-23B622D84F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0091F06-C749-472A-BFAE-BC1DE01DFF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A05B27-057A-45C0-8760-8C28BBF415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22692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B3F24DF-9C68-4158-A808-98AA18ECFE6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ED0F785-9308-453F-BA11-2D64ECD75E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3A25952-88A2-456D-B0C4-29871E3AD1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6DE90-0AAC-4704-9E25-8DA8BDEFC4C8}" type="datetimeFigureOut">
              <a:rPr kumimoji="1" lang="ja-JP" altLang="en-US" smtClean="0"/>
              <a:pPr/>
              <a:t>2024/1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B454C68-933C-460B-92E8-8280FBD03D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1917E6D-4923-4515-8739-87E83C12C1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A05B27-057A-45C0-8760-8C28BBF415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21975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0A0DC28-B6F4-4499-A717-0D09D4117A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4FB1858-33CF-40F7-9C23-34A37E33756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0AF6FEF-5D85-47C1-919F-752626C6B2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6DE90-0AAC-4704-9E25-8DA8BDEFC4C8}" type="datetimeFigureOut">
              <a:rPr kumimoji="1" lang="ja-JP" altLang="en-US" smtClean="0"/>
              <a:pPr/>
              <a:t>2024/1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403CA9D-35D2-41AC-9CE7-B395E66052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1795116-EA71-4D1E-848F-5CD2B3F62F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A05B27-057A-45C0-8760-8C28BBF415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60082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923025D-A7E4-469C-BC80-D5920A5C45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CCEACD2-DEFA-44F8-A185-8F6AD19C4C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F264FC3-CBA4-4E7E-B1F4-E388915EB6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6DE90-0AAC-4704-9E25-8DA8BDEFC4C8}" type="datetimeFigureOut">
              <a:rPr kumimoji="1" lang="ja-JP" altLang="en-US" smtClean="0"/>
              <a:pPr/>
              <a:t>2024/1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344F0E7-FC26-4D0A-9CD8-889CFED5F1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79816A7-97A6-41ED-8E65-3C3F7B7DEB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A05B27-057A-45C0-8760-8C28BBF415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21375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3B7BEFA-8247-4B5A-92BA-5E44E74733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BAC7344-B9B5-42AF-A11B-78762A8D20E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EEA78FE-AC32-487F-B987-9541B9D402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74794A1-91D5-4695-9015-9F450BC6F3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6DE90-0AAC-4704-9E25-8DA8BDEFC4C8}" type="datetimeFigureOut">
              <a:rPr kumimoji="1" lang="ja-JP" altLang="en-US" smtClean="0"/>
              <a:pPr/>
              <a:t>2024/1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8B244DF-39CC-4757-A1B6-891A2C7379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4EBA2F2-4724-4C8B-A84B-808BDD78C1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A05B27-057A-45C0-8760-8C28BBF415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76271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3175A64-6BE1-4D5C-8840-04F705379D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357763B-B121-4F10-AE28-26E93C1078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680FD73-5F35-4042-BE19-B0D7CC23C1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4FC0C53D-2669-4014-8BF9-B65A6C3BB67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450296A-321D-4351-AAC1-FC25A25C3D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39C8937-3A44-4331-8E66-82584D93D5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6DE90-0AAC-4704-9E25-8DA8BDEFC4C8}" type="datetimeFigureOut">
              <a:rPr kumimoji="1" lang="ja-JP" altLang="en-US" smtClean="0"/>
              <a:pPr/>
              <a:t>2024/1/3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347C366-2671-47DA-B7E4-3C3C4CEBD9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020C288-95B0-46F2-8869-68E9D8E05B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A05B27-057A-45C0-8760-8C28BBF415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04539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0F3261F-4D8C-4D6B-B928-C17A03BBD7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DDAE99B-2275-40C1-8878-A8E1348B5D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6DE90-0AAC-4704-9E25-8DA8BDEFC4C8}" type="datetimeFigureOut">
              <a:rPr kumimoji="1" lang="ja-JP" altLang="en-US" smtClean="0"/>
              <a:pPr/>
              <a:t>2024/1/3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704290A9-FA00-41B4-84B6-1F07A0D389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E17C8B8-CB5D-499F-BB14-0C75378C11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A05B27-057A-45C0-8760-8C28BBF415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47474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351E075-FB01-49AA-84C7-DC87D57427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6DE90-0AAC-4704-9E25-8DA8BDEFC4C8}" type="datetimeFigureOut">
              <a:rPr kumimoji="1" lang="ja-JP" altLang="en-US" smtClean="0"/>
              <a:pPr/>
              <a:t>2024/1/3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91B04893-6236-4E80-86FC-EB4B4B9ED1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471BAA7-C3C6-420A-821F-624B071699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A05B27-057A-45C0-8760-8C28BBF415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55954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039C57B-0E7D-4276-8249-40445524E8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38FF2E2-D0F5-4147-BE6E-5264A004522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0651AE8-7FAE-4A2D-A0DA-3E2FFB7742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682D06C-978F-4FF9-8B9C-E9B618E323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6DE90-0AAC-4704-9E25-8DA8BDEFC4C8}" type="datetimeFigureOut">
              <a:rPr kumimoji="1" lang="ja-JP" altLang="en-US" smtClean="0"/>
              <a:pPr/>
              <a:t>2024/1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E66A82A-D73A-48C6-B10B-EDA20CF13A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3980C21-B422-4734-9FE8-BBD89CA95F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A05B27-057A-45C0-8760-8C28BBF415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97587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2D70F40-DAAE-4339-BE97-970EB65931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A1A54FE-3CE1-4651-BDA5-5A60695470F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37915AA-151C-4634-8698-C63CC6C755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9A61BDF-D589-4579-9201-0E2B605AE8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6DE90-0AAC-4704-9E25-8DA8BDEFC4C8}" type="datetimeFigureOut">
              <a:rPr kumimoji="1" lang="ja-JP" altLang="en-US" smtClean="0"/>
              <a:pPr/>
              <a:t>2024/1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B0DE3E1-61E0-41AB-BD65-D1A5EB4828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11A10D8-0258-4ED0-A11E-1B584A7C8C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A05B27-057A-45C0-8760-8C28BBF415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34175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C6AB23E4-A651-4C78-8B88-BCA60345D1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D4CECFD-90A5-4B80-857F-EA401DA7CE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2D774A6-774C-49A8-B853-E942A7B5416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76DE90-0AAC-4704-9E25-8DA8BDEFC4C8}" type="datetimeFigureOut">
              <a:rPr kumimoji="1" lang="ja-JP" altLang="en-US" smtClean="0"/>
              <a:pPr/>
              <a:t>2024/1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9B8F365-18F7-46BE-AB11-7102EAFA435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7518349-9C24-4FD2-A876-6723FBB6256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A05B27-057A-45C0-8760-8C28BBF415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6481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正方形/長方形 20"/>
          <p:cNvSpPr/>
          <p:nvPr/>
        </p:nvSpPr>
        <p:spPr>
          <a:xfrm>
            <a:off x="32658" y="609600"/>
            <a:ext cx="12039600" cy="2830286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4" name="テキスト ボックス 113"/>
          <p:cNvSpPr txBox="1"/>
          <p:nvPr/>
        </p:nvSpPr>
        <p:spPr>
          <a:xfrm>
            <a:off x="41277" y="26622"/>
            <a:ext cx="265970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Times New Roman" pitchFamily="18" charset="0"/>
                <a:cs typeface="Times New Roman" pitchFamily="18" charset="0"/>
              </a:rPr>
              <a:t>Supplementary Fig</a:t>
            </a:r>
            <a:r>
              <a:rPr lang="en-US" altLang="ja-JP" sz="2000" dirty="0">
                <a:latin typeface="Times New Roman" pitchFamily="18" charset="0"/>
                <a:cs typeface="Times New Roman" pitchFamily="18" charset="0"/>
              </a:rPr>
              <a:t>ure 1</a:t>
            </a:r>
            <a:endParaRPr kumimoji="1" lang="ja-JP" altLang="en-US" sz="20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64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 rot="10800000">
            <a:off x="47533" y="620687"/>
            <a:ext cx="2730608" cy="280894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65" name="Picture 3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 rot="10800000">
            <a:off x="2622782" y="620687"/>
            <a:ext cx="2563812" cy="27972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66" name="Picture 4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 rot="10800000">
            <a:off x="5047994" y="620687"/>
            <a:ext cx="2437517" cy="27972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67" name="Picture 5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 rot="10800000">
            <a:off x="7381563" y="614137"/>
            <a:ext cx="2401495" cy="28059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68" name="Picture 6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 rot="10800000">
            <a:off x="9707157" y="612799"/>
            <a:ext cx="2321456" cy="27969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6" name="テキスト ボックス 115"/>
          <p:cNvSpPr txBox="1"/>
          <p:nvPr/>
        </p:nvSpPr>
        <p:spPr>
          <a:xfrm>
            <a:off x="747095" y="3024996"/>
            <a:ext cx="137890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Cerebellum</a:t>
            </a:r>
            <a:endParaRPr kumimoji="1" lang="ja-JP" altLang="en-US" sz="2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9" name="テキスト ボックス 118"/>
          <p:cNvSpPr txBox="1"/>
          <p:nvPr/>
        </p:nvSpPr>
        <p:spPr>
          <a:xfrm>
            <a:off x="2689489" y="2441090"/>
            <a:ext cx="258596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Lateral temporal cortex</a:t>
            </a:r>
            <a:endParaRPr kumimoji="1" lang="ja-JP" altLang="en-US" sz="2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0" name="テキスト ボックス 119"/>
          <p:cNvSpPr txBox="1"/>
          <p:nvPr/>
        </p:nvSpPr>
        <p:spPr>
          <a:xfrm>
            <a:off x="10221187" y="2036920"/>
            <a:ext cx="12378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err="1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Precuneus</a:t>
            </a:r>
            <a:endParaRPr kumimoji="1" lang="ja-JP" altLang="en-US" sz="2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2" name="テキスト ボックス 151"/>
          <p:cNvSpPr txBox="1"/>
          <p:nvPr/>
        </p:nvSpPr>
        <p:spPr>
          <a:xfrm>
            <a:off x="9614784" y="642308"/>
            <a:ext cx="237276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Middle frontal cortex</a:t>
            </a:r>
            <a:endParaRPr kumimoji="1" lang="ja-JP" altLang="en-US" sz="2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3" name="テキスト ボックス 152"/>
          <p:cNvSpPr txBox="1"/>
          <p:nvPr/>
        </p:nvSpPr>
        <p:spPr>
          <a:xfrm>
            <a:off x="10078519" y="2992670"/>
            <a:ext cx="166904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Parietal cortex</a:t>
            </a:r>
            <a:endParaRPr kumimoji="1" lang="ja-JP" altLang="en-US" sz="2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4" name="テキスト ボックス 153"/>
          <p:cNvSpPr txBox="1"/>
          <p:nvPr/>
        </p:nvSpPr>
        <p:spPr>
          <a:xfrm>
            <a:off x="7711835" y="3050897"/>
            <a:ext cx="182614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Occipital cortex</a:t>
            </a:r>
            <a:endParaRPr kumimoji="1" lang="ja-JP" altLang="en-US" sz="2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6" name="テキスト ボックス 155"/>
          <p:cNvSpPr txBox="1"/>
          <p:nvPr/>
        </p:nvSpPr>
        <p:spPr>
          <a:xfrm>
            <a:off x="7053390" y="1595446"/>
            <a:ext cx="108074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err="1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Putamen</a:t>
            </a:r>
            <a:endParaRPr kumimoji="1" lang="ja-JP" altLang="en-US" sz="2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7" name="テキスト ボックス 156"/>
          <p:cNvSpPr txBox="1"/>
          <p:nvPr/>
        </p:nvSpPr>
        <p:spPr>
          <a:xfrm>
            <a:off x="8055246" y="1038235"/>
            <a:ext cx="10246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Caudate</a:t>
            </a:r>
            <a:endParaRPr kumimoji="1" lang="ja-JP" altLang="en-US" sz="2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8" name="テキスト ボックス 157"/>
          <p:cNvSpPr txBox="1"/>
          <p:nvPr/>
        </p:nvSpPr>
        <p:spPr>
          <a:xfrm>
            <a:off x="7991872" y="2278611"/>
            <a:ext cx="11945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Thalamus</a:t>
            </a:r>
            <a:endParaRPr kumimoji="1" lang="ja-JP" altLang="en-US" sz="2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9" name="テキスト ボックス 158"/>
          <p:cNvSpPr txBox="1"/>
          <p:nvPr/>
        </p:nvSpPr>
        <p:spPr>
          <a:xfrm>
            <a:off x="5200035" y="1858098"/>
            <a:ext cx="222689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Nucleus </a:t>
            </a:r>
            <a:r>
              <a:rPr lang="en-US" altLang="ja-JP" sz="2000" dirty="0" err="1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accumbens</a:t>
            </a:r>
            <a:endParaRPr kumimoji="1" lang="ja-JP" altLang="en-US" sz="2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1" name="テキスト ボックス 160"/>
          <p:cNvSpPr txBox="1"/>
          <p:nvPr/>
        </p:nvSpPr>
        <p:spPr>
          <a:xfrm>
            <a:off x="1079646" y="1495003"/>
            <a:ext cx="77743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Pons</a:t>
            </a:r>
            <a:endParaRPr kumimoji="1" lang="ja-JP" altLang="en-US" sz="2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2" name="テキスト ボックス 161"/>
          <p:cNvSpPr txBox="1"/>
          <p:nvPr/>
        </p:nvSpPr>
        <p:spPr>
          <a:xfrm>
            <a:off x="3403786" y="1435272"/>
            <a:ext cx="11368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Midbrain</a:t>
            </a:r>
            <a:endParaRPr kumimoji="1" lang="ja-JP" altLang="en-US" sz="2000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49B30916-F959-3EF4-2B04-FECB70B65671}"/>
              </a:ext>
            </a:extLst>
          </p:cNvPr>
          <p:cNvSpPr txBox="1"/>
          <p:nvPr/>
        </p:nvSpPr>
        <p:spPr>
          <a:xfrm>
            <a:off x="0" y="3534027"/>
            <a:ext cx="11802359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A representative image of the manual region of interest. </a:t>
            </a:r>
            <a:r>
              <a:rPr lang="en-US" altLang="ja-JP" sz="1600" dirty="0">
                <a:latin typeface="Times New Roman" pitchFamily="18" charset="0"/>
                <a:cs typeface="Times New Roman" pitchFamily="18" charset="0"/>
              </a:rPr>
              <a:t>Polymorphic region of interests were drawn bilaterally on the cerebellum, pons, midbrain</a:t>
            </a:r>
            <a:r>
              <a:rPr lang="en-US" altLang="ja-JP" sz="1600">
                <a:latin typeface="Times New Roman" pitchFamily="18" charset="0"/>
                <a:cs typeface="Times New Roman" pitchFamily="18" charset="0"/>
              </a:rPr>
              <a:t>, nucleus accumbens</a:t>
            </a:r>
            <a:r>
              <a:rPr lang="en-US" altLang="ja-JP" sz="1600" dirty="0">
                <a:latin typeface="Times New Roman" pitchFamily="18" charset="0"/>
                <a:cs typeface="Times New Roman" pitchFamily="18" charset="0"/>
              </a:rPr>
              <a:t>, caudate, putamen, thalamus, precuneus, middle frontal cortex, lateral temporal cortex, parietal cortex, and occipital cortex on the MRI scan. </a:t>
            </a:r>
            <a:endParaRPr lang="ja-JP" altLang="ja-JP" sz="1600" dirty="0">
              <a:latin typeface="Times New Roman" pitchFamily="18" charset="0"/>
              <a:cs typeface="Times New Roman" pitchFamily="18" charset="0"/>
            </a:endParaRPr>
          </a:p>
          <a:p>
            <a:endParaRPr kumimoji="1" lang="ja-JP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169288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1</TotalTime>
  <Words>78</Words>
  <Application>Microsoft Office PowerPoint</Application>
  <PresentationFormat>ワイド画面</PresentationFormat>
  <Paragraphs>1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tsuhiro Terada</dc:creator>
  <cp:lastModifiedBy>hmpmed</cp:lastModifiedBy>
  <cp:revision>45</cp:revision>
  <dcterms:created xsi:type="dcterms:W3CDTF">2021-11-05T11:54:06Z</dcterms:created>
  <dcterms:modified xsi:type="dcterms:W3CDTF">2024-01-30T01:17:19Z</dcterms:modified>
</cp:coreProperties>
</file>